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4875"/>
    <p:restoredTop sz="94694"/>
  </p:normalViewPr>
  <p:slideViewPr>
    <p:cSldViewPr snapToGrid="0" snapToObjects="1">
      <p:cViewPr varScale="1">
        <p:scale>
          <a:sx n="137" d="100"/>
          <a:sy n="137" d="100"/>
        </p:scale>
        <p:origin x="2360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3152286858872624"/>
          <c:y val="0.2167888882572527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3</c:f>
              <c:strCache>
                <c:ptCount val="1"/>
                <c:pt idx="0">
                  <c:v>Barto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55:$J$55</c:f>
                <c:numCache>
                  <c:formatCode>General</c:formatCode>
                  <c:ptCount val="9"/>
                  <c:pt idx="0">
                    <c:v>1.5084485824217E-2</c:v>
                  </c:pt>
                  <c:pt idx="1">
                    <c:v>6.3975159446660297E-3</c:v>
                  </c:pt>
                  <c:pt idx="2">
                    <c:v>9.5392900430185404E-2</c:v>
                  </c:pt>
                  <c:pt idx="3">
                    <c:v>1.81260794904675E-2</c:v>
                  </c:pt>
                  <c:pt idx="4">
                    <c:v>1.8140655134236301E-2</c:v>
                  </c:pt>
                  <c:pt idx="5">
                    <c:v>3.8899401824420997E-2</c:v>
                  </c:pt>
                  <c:pt idx="6">
                    <c:v>6.9852999477976296E-2</c:v>
                  </c:pt>
                  <c:pt idx="7">
                    <c:v>1.35845687320257E-2</c:v>
                  </c:pt>
                  <c:pt idx="8">
                    <c:v>4.7265786811545897E-2</c:v>
                  </c:pt>
                </c:numCache>
              </c:numRef>
            </c:plus>
            <c:minus>
              <c:numRef>
                <c:f>'Sheet 1 - county estimates'!$B$55:$J$55</c:f>
                <c:numCache>
                  <c:formatCode>General</c:formatCode>
                  <c:ptCount val="9"/>
                  <c:pt idx="0">
                    <c:v>1.5084485824217E-2</c:v>
                  </c:pt>
                  <c:pt idx="1">
                    <c:v>6.3975159446660297E-3</c:v>
                  </c:pt>
                  <c:pt idx="2">
                    <c:v>9.5392900430185404E-2</c:v>
                  </c:pt>
                  <c:pt idx="3">
                    <c:v>1.81260794904675E-2</c:v>
                  </c:pt>
                  <c:pt idx="4">
                    <c:v>1.8140655134236301E-2</c:v>
                  </c:pt>
                  <c:pt idx="5">
                    <c:v>3.8899401824420997E-2</c:v>
                  </c:pt>
                  <c:pt idx="6">
                    <c:v>6.9852999477976296E-2</c:v>
                  </c:pt>
                  <c:pt idx="7">
                    <c:v>1.35845687320257E-2</c:v>
                  </c:pt>
                  <c:pt idx="8">
                    <c:v>4.72657868115458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2:$J$2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3:$J$3</c:f>
              <c:numCache>
                <c:formatCode>General</c:formatCode>
                <c:ptCount val="9"/>
                <c:pt idx="0">
                  <c:v>0.49351258462952602</c:v>
                </c:pt>
                <c:pt idx="1">
                  <c:v>0.366261731745187</c:v>
                </c:pt>
                <c:pt idx="2">
                  <c:v>0.37925131439644399</c:v>
                </c:pt>
                <c:pt idx="3">
                  <c:v>0.235153074693248</c:v>
                </c:pt>
                <c:pt idx="4">
                  <c:v>0.179163040085729</c:v>
                </c:pt>
                <c:pt idx="5">
                  <c:v>0.60288009455646796</c:v>
                </c:pt>
                <c:pt idx="6">
                  <c:v>0.40990893274228601</c:v>
                </c:pt>
                <c:pt idx="7">
                  <c:v>0.50897995662988205</c:v>
                </c:pt>
                <c:pt idx="8">
                  <c:v>0.767442479860133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192-5147-AF3A-F39762CFCC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124292369563789"/>
          <c:y val="0.240874735654202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5</c:f>
              <c:strCache>
                <c:ptCount val="1"/>
                <c:pt idx="0">
                  <c:v>Dickinso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56:$J$56</c:f>
                <c:numCache>
                  <c:formatCode>General</c:formatCode>
                  <c:ptCount val="9"/>
                  <c:pt idx="0">
                    <c:v>1.3936905021131899E-2</c:v>
                  </c:pt>
                  <c:pt idx="1">
                    <c:v>1.00792618475418E-2</c:v>
                  </c:pt>
                  <c:pt idx="2">
                    <c:v>6.9263957784112998E-2</c:v>
                  </c:pt>
                  <c:pt idx="3">
                    <c:v>1.9309345940994101E-2</c:v>
                  </c:pt>
                  <c:pt idx="4">
                    <c:v>1.7733901540459E-2</c:v>
                  </c:pt>
                  <c:pt idx="5">
                    <c:v>2.8918585749873601E-2</c:v>
                  </c:pt>
                  <c:pt idx="6">
                    <c:v>6.4973132792725305E-2</c:v>
                  </c:pt>
                  <c:pt idx="7">
                    <c:v>1.38382155705948E-2</c:v>
                  </c:pt>
                  <c:pt idx="8">
                    <c:v>2.3986149271493399E-2</c:v>
                  </c:pt>
                </c:numCache>
              </c:numRef>
            </c:plus>
            <c:minus>
              <c:numRef>
                <c:f>'Sheet 1 - county estimates'!$B$56:$J$56</c:f>
                <c:numCache>
                  <c:formatCode>General</c:formatCode>
                  <c:ptCount val="9"/>
                  <c:pt idx="0">
                    <c:v>1.3936905021131899E-2</c:v>
                  </c:pt>
                  <c:pt idx="1">
                    <c:v>1.00792618475418E-2</c:v>
                  </c:pt>
                  <c:pt idx="2">
                    <c:v>6.9263957784112998E-2</c:v>
                  </c:pt>
                  <c:pt idx="3">
                    <c:v>1.9309345940994101E-2</c:v>
                  </c:pt>
                  <c:pt idx="4">
                    <c:v>1.7733901540459E-2</c:v>
                  </c:pt>
                  <c:pt idx="5">
                    <c:v>2.8918585749873601E-2</c:v>
                  </c:pt>
                  <c:pt idx="6">
                    <c:v>6.4973132792725305E-2</c:v>
                  </c:pt>
                  <c:pt idx="7">
                    <c:v>1.38382155705948E-2</c:v>
                  </c:pt>
                  <c:pt idx="8">
                    <c:v>2.39861492714933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4:$J$4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5:$J$5</c:f>
              <c:numCache>
                <c:formatCode>General</c:formatCode>
                <c:ptCount val="9"/>
                <c:pt idx="0">
                  <c:v>0.48363449454401303</c:v>
                </c:pt>
                <c:pt idx="1">
                  <c:v>0.48178881945713697</c:v>
                </c:pt>
                <c:pt idx="2">
                  <c:v>0.59574609894692998</c:v>
                </c:pt>
                <c:pt idx="3">
                  <c:v>0.29345815134577902</c:v>
                </c:pt>
                <c:pt idx="4">
                  <c:v>0.19047535024461801</c:v>
                </c:pt>
                <c:pt idx="5">
                  <c:v>0.58739996275113704</c:v>
                </c:pt>
                <c:pt idx="6">
                  <c:v>0.51134847968911801</c:v>
                </c:pt>
                <c:pt idx="7">
                  <c:v>0.56960753193169</c:v>
                </c:pt>
                <c:pt idx="8">
                  <c:v>0.853915712209909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B8-2943-BC54-EA6D38DD32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5483555353600835"/>
          <c:y val="0.2165880279688477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7</c:f>
              <c:strCache>
                <c:ptCount val="1"/>
                <c:pt idx="0">
                  <c:v>Elli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57:$J$57</c:f>
                <c:numCache>
                  <c:formatCode>General</c:formatCode>
                  <c:ptCount val="9"/>
                  <c:pt idx="0">
                    <c:v>1.9592905892010602E-2</c:v>
                  </c:pt>
                  <c:pt idx="1">
                    <c:v>1.1211263831524799E-2</c:v>
                  </c:pt>
                  <c:pt idx="2">
                    <c:v>0.11813615344243</c:v>
                  </c:pt>
                  <c:pt idx="3">
                    <c:v>2.3181848509970002E-2</c:v>
                  </c:pt>
                  <c:pt idx="4">
                    <c:v>3.80145173209313E-2</c:v>
                  </c:pt>
                  <c:pt idx="5">
                    <c:v>2.05107408186227E-2</c:v>
                  </c:pt>
                  <c:pt idx="6">
                    <c:v>7.1966669085571006E-2</c:v>
                  </c:pt>
                  <c:pt idx="7">
                    <c:v>7.1602744691180598E-3</c:v>
                  </c:pt>
                  <c:pt idx="8">
                    <c:v>2.4748345983928E-2</c:v>
                  </c:pt>
                </c:numCache>
              </c:numRef>
            </c:plus>
            <c:minus>
              <c:numRef>
                <c:f>'Sheet 1 - county estimates'!$B$57:$J$57</c:f>
                <c:numCache>
                  <c:formatCode>General</c:formatCode>
                  <c:ptCount val="9"/>
                  <c:pt idx="0">
                    <c:v>1.9592905892010602E-2</c:v>
                  </c:pt>
                  <c:pt idx="1">
                    <c:v>1.1211263831524799E-2</c:v>
                  </c:pt>
                  <c:pt idx="2">
                    <c:v>0.11813615344243</c:v>
                  </c:pt>
                  <c:pt idx="3">
                    <c:v>2.3181848509970002E-2</c:v>
                  </c:pt>
                  <c:pt idx="4">
                    <c:v>3.80145173209313E-2</c:v>
                  </c:pt>
                  <c:pt idx="5">
                    <c:v>2.05107408186227E-2</c:v>
                  </c:pt>
                  <c:pt idx="6">
                    <c:v>7.1966669085571006E-2</c:v>
                  </c:pt>
                  <c:pt idx="7">
                    <c:v>7.1602744691180598E-3</c:v>
                  </c:pt>
                  <c:pt idx="8">
                    <c:v>2.474834598392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6:$J$6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7:$J$7</c:f>
              <c:numCache>
                <c:formatCode>General</c:formatCode>
                <c:ptCount val="9"/>
                <c:pt idx="0">
                  <c:v>0.62481264555551796</c:v>
                </c:pt>
                <c:pt idx="1">
                  <c:v>0.53399681410933397</c:v>
                </c:pt>
                <c:pt idx="2">
                  <c:v>0.52476567265481899</c:v>
                </c:pt>
                <c:pt idx="3">
                  <c:v>0.39341243817800498</c:v>
                </c:pt>
                <c:pt idx="4">
                  <c:v>0.35990573880339999</c:v>
                </c:pt>
                <c:pt idx="5">
                  <c:v>0.72421231581616097</c:v>
                </c:pt>
                <c:pt idx="6">
                  <c:v>0.44348778305990699</c:v>
                </c:pt>
                <c:pt idx="7">
                  <c:v>0.58066743132415799</c:v>
                </c:pt>
                <c:pt idx="8">
                  <c:v>0.842137572718851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A2-5A46-BFD4-75C799451B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423621575447354"/>
          <c:y val="0.240874735654202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13</c:f>
              <c:strCache>
                <c:ptCount val="1"/>
                <c:pt idx="0">
                  <c:v>Gear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60:$J$60</c:f>
                <c:numCache>
                  <c:formatCode>General</c:formatCode>
                  <c:ptCount val="9"/>
                  <c:pt idx="0">
                    <c:v>2.9628296946221901E-2</c:v>
                  </c:pt>
                  <c:pt idx="1">
                    <c:v>2.2582031360220599E-2</c:v>
                  </c:pt>
                  <c:pt idx="2">
                    <c:v>6.5214066060251194E-2</c:v>
                  </c:pt>
                  <c:pt idx="3">
                    <c:v>3.89030299067748E-2</c:v>
                  </c:pt>
                  <c:pt idx="4">
                    <c:v>4.6678912644144997E-2</c:v>
                  </c:pt>
                  <c:pt idx="5">
                    <c:v>2.5629385901692399E-2</c:v>
                  </c:pt>
                  <c:pt idx="6">
                    <c:v>6.3351529702571893E-2</c:v>
                  </c:pt>
                  <c:pt idx="7">
                    <c:v>2.1454195163473699E-2</c:v>
                  </c:pt>
                  <c:pt idx="8">
                    <c:v>7.9524921157835098E-3</c:v>
                  </c:pt>
                </c:numCache>
              </c:numRef>
            </c:plus>
            <c:minus>
              <c:numRef>
                <c:f>'Sheet 1 - county estimates'!$B$60:$J$60</c:f>
                <c:numCache>
                  <c:formatCode>General</c:formatCode>
                  <c:ptCount val="9"/>
                  <c:pt idx="0">
                    <c:v>2.9628296946221901E-2</c:v>
                  </c:pt>
                  <c:pt idx="1">
                    <c:v>2.2582031360220599E-2</c:v>
                  </c:pt>
                  <c:pt idx="2">
                    <c:v>6.5214066060251194E-2</c:v>
                  </c:pt>
                  <c:pt idx="3">
                    <c:v>3.89030299067748E-2</c:v>
                  </c:pt>
                  <c:pt idx="4">
                    <c:v>4.6678912644144997E-2</c:v>
                  </c:pt>
                  <c:pt idx="5">
                    <c:v>2.5629385901692399E-2</c:v>
                  </c:pt>
                  <c:pt idx="6">
                    <c:v>6.3351529702571893E-2</c:v>
                  </c:pt>
                  <c:pt idx="7">
                    <c:v>2.1454195163473699E-2</c:v>
                  </c:pt>
                  <c:pt idx="8">
                    <c:v>7.952492115783509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12:$J$12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13:$J$13</c:f>
              <c:numCache>
                <c:formatCode>General</c:formatCode>
                <c:ptCount val="9"/>
                <c:pt idx="0">
                  <c:v>0.59860705942785997</c:v>
                </c:pt>
                <c:pt idx="1">
                  <c:v>0.64368077431791804</c:v>
                </c:pt>
                <c:pt idx="2">
                  <c:v>0.709545726907439</c:v>
                </c:pt>
                <c:pt idx="3">
                  <c:v>0.42209959535454</c:v>
                </c:pt>
                <c:pt idx="4">
                  <c:v>0.30030413798326799</c:v>
                </c:pt>
                <c:pt idx="5">
                  <c:v>0.71508962783669505</c:v>
                </c:pt>
                <c:pt idx="6">
                  <c:v>0.59744522030991598</c:v>
                </c:pt>
                <c:pt idx="7">
                  <c:v>0.69520536186117898</c:v>
                </c:pt>
                <c:pt idx="8">
                  <c:v>0.92651716192427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07-A941-8E8E-CD5905A8DD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3342399021707534"/>
          <c:y val="0.2488760035118968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15</c:f>
              <c:strCache>
                <c:ptCount val="1"/>
                <c:pt idx="0">
                  <c:v>Greele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61:$J$61</c:f>
                <c:numCache>
                  <c:formatCode>General</c:formatCode>
                  <c:ptCount val="9"/>
                  <c:pt idx="0">
                    <c:v>1.2682631608226001E-2</c:v>
                  </c:pt>
                  <c:pt idx="1">
                    <c:v>7.3135890070702503E-3</c:v>
                  </c:pt>
                  <c:pt idx="2">
                    <c:v>2.43706582337191E-2</c:v>
                  </c:pt>
                  <c:pt idx="3">
                    <c:v>5.0553883905977998E-3</c:v>
                  </c:pt>
                  <c:pt idx="4">
                    <c:v>3.8655803910446402E-3</c:v>
                  </c:pt>
                  <c:pt idx="5">
                    <c:v>1.98856382391185E-2</c:v>
                  </c:pt>
                  <c:pt idx="6">
                    <c:v>2.8958653254267299E-2</c:v>
                  </c:pt>
                  <c:pt idx="7">
                    <c:v>1.29620103104161E-2</c:v>
                  </c:pt>
                  <c:pt idx="8">
                    <c:v>7.0969891335954993E-2</c:v>
                  </c:pt>
                </c:numCache>
              </c:numRef>
            </c:plus>
            <c:minus>
              <c:numRef>
                <c:f>'Sheet 1 - county estimates'!$B$61:$J$61</c:f>
                <c:numCache>
                  <c:formatCode>General</c:formatCode>
                  <c:ptCount val="9"/>
                  <c:pt idx="0">
                    <c:v>1.2682631608226001E-2</c:v>
                  </c:pt>
                  <c:pt idx="1">
                    <c:v>7.3135890070702503E-3</c:v>
                  </c:pt>
                  <c:pt idx="2">
                    <c:v>2.43706582337191E-2</c:v>
                  </c:pt>
                  <c:pt idx="3">
                    <c:v>5.0553883905977998E-3</c:v>
                  </c:pt>
                  <c:pt idx="4">
                    <c:v>3.8655803910446402E-3</c:v>
                  </c:pt>
                  <c:pt idx="5">
                    <c:v>1.98856382391185E-2</c:v>
                  </c:pt>
                  <c:pt idx="6">
                    <c:v>2.8958653254267299E-2</c:v>
                  </c:pt>
                  <c:pt idx="7">
                    <c:v>1.29620103104161E-2</c:v>
                  </c:pt>
                  <c:pt idx="8">
                    <c:v>7.09698913359549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14:$J$14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15:$J$15</c:f>
              <c:numCache>
                <c:formatCode>General</c:formatCode>
                <c:ptCount val="9"/>
                <c:pt idx="0">
                  <c:v>0.25119131961875402</c:v>
                </c:pt>
                <c:pt idx="1">
                  <c:v>0.27196524990938897</c:v>
                </c:pt>
                <c:pt idx="2">
                  <c:v>0.33584392341848601</c:v>
                </c:pt>
                <c:pt idx="3">
                  <c:v>9.9010219028157001E-2</c:v>
                </c:pt>
                <c:pt idx="4">
                  <c:v>7.1634430537623001E-2</c:v>
                </c:pt>
                <c:pt idx="5">
                  <c:v>0.32542515478963602</c:v>
                </c:pt>
                <c:pt idx="6">
                  <c:v>0.20696182009297301</c:v>
                </c:pt>
                <c:pt idx="7">
                  <c:v>0.31086904475326899</c:v>
                </c:pt>
                <c:pt idx="8">
                  <c:v>0.523003366941355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AC-0548-ADE0-B76905D58B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3679271760157973"/>
          <c:y val="0.240874735654202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11</c:f>
              <c:strCache>
                <c:ptCount val="1"/>
                <c:pt idx="0">
                  <c:v>Finne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59:$J$59</c:f>
                <c:numCache>
                  <c:formatCode>General</c:formatCode>
                  <c:ptCount val="9"/>
                  <c:pt idx="0">
                    <c:v>1.81431347532004E-2</c:v>
                  </c:pt>
                  <c:pt idx="1">
                    <c:v>7.2170863827117704E-3</c:v>
                  </c:pt>
                  <c:pt idx="2">
                    <c:v>4.9610634115997303E-2</c:v>
                  </c:pt>
                  <c:pt idx="3">
                    <c:v>9.1631686214061602E-3</c:v>
                  </c:pt>
                  <c:pt idx="4">
                    <c:v>8.1837934808800007E-3</c:v>
                  </c:pt>
                  <c:pt idx="5">
                    <c:v>2.8100204951711099E-2</c:v>
                  </c:pt>
                  <c:pt idx="6">
                    <c:v>5.2972228011135998E-2</c:v>
                  </c:pt>
                  <c:pt idx="7">
                    <c:v>1.3263374723347199E-2</c:v>
                  </c:pt>
                  <c:pt idx="8">
                    <c:v>6.9547169253621005E-2</c:v>
                  </c:pt>
                </c:numCache>
              </c:numRef>
            </c:plus>
            <c:minus>
              <c:numRef>
                <c:f>'Sheet 1 - county estimates'!$B$59:$J$59</c:f>
                <c:numCache>
                  <c:formatCode>General</c:formatCode>
                  <c:ptCount val="9"/>
                  <c:pt idx="0">
                    <c:v>1.81431347532004E-2</c:v>
                  </c:pt>
                  <c:pt idx="1">
                    <c:v>7.2170863827117704E-3</c:v>
                  </c:pt>
                  <c:pt idx="2">
                    <c:v>4.9610634115997303E-2</c:v>
                  </c:pt>
                  <c:pt idx="3">
                    <c:v>9.1631686214061602E-3</c:v>
                  </c:pt>
                  <c:pt idx="4">
                    <c:v>8.1837934808800007E-3</c:v>
                  </c:pt>
                  <c:pt idx="5">
                    <c:v>2.8100204951711099E-2</c:v>
                  </c:pt>
                  <c:pt idx="6">
                    <c:v>5.2972228011135998E-2</c:v>
                  </c:pt>
                  <c:pt idx="7">
                    <c:v>1.3263374723347199E-2</c:v>
                  </c:pt>
                  <c:pt idx="8">
                    <c:v>6.954716925362100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10:$J$10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11:$J$11</c:f>
              <c:numCache>
                <c:formatCode>General</c:formatCode>
                <c:ptCount val="9"/>
                <c:pt idx="0">
                  <c:v>0.35161655642510797</c:v>
                </c:pt>
                <c:pt idx="1">
                  <c:v>0.33449848043673902</c:v>
                </c:pt>
                <c:pt idx="2">
                  <c:v>0.32780576971228897</c:v>
                </c:pt>
                <c:pt idx="3">
                  <c:v>0.15199490222699399</c:v>
                </c:pt>
                <c:pt idx="4">
                  <c:v>9.6527766121584396E-2</c:v>
                </c:pt>
                <c:pt idx="5">
                  <c:v>0.40890674931250598</c:v>
                </c:pt>
                <c:pt idx="6">
                  <c:v>0.31281483451060799</c:v>
                </c:pt>
                <c:pt idx="7">
                  <c:v>0.40129480058987999</c:v>
                </c:pt>
                <c:pt idx="8">
                  <c:v>0.53089382120245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E7-CE45-AA82-98D878C10C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1138623730497353"/>
          <c:y val="0.2326315855961697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9</c:f>
              <c:strCache>
                <c:ptCount val="1"/>
                <c:pt idx="0">
                  <c:v>Ellsworth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58:$J$58</c:f>
                <c:numCache>
                  <c:formatCode>General</c:formatCode>
                  <c:ptCount val="9"/>
                  <c:pt idx="0">
                    <c:v>2.0727779541100701E-2</c:v>
                  </c:pt>
                  <c:pt idx="1">
                    <c:v>2.0386245192550799E-2</c:v>
                  </c:pt>
                  <c:pt idx="2">
                    <c:v>0.13320546279843701</c:v>
                  </c:pt>
                  <c:pt idx="3">
                    <c:v>2.2551971558690601E-2</c:v>
                  </c:pt>
                  <c:pt idx="4">
                    <c:v>3.3680008492847198E-2</c:v>
                  </c:pt>
                  <c:pt idx="5">
                    <c:v>3.17515101838661E-2</c:v>
                  </c:pt>
                  <c:pt idx="6">
                    <c:v>6.8010404264371702E-2</c:v>
                  </c:pt>
                  <c:pt idx="7">
                    <c:v>2.1785332575781101E-2</c:v>
                  </c:pt>
                  <c:pt idx="8">
                    <c:v>2.5754216808995398E-2</c:v>
                  </c:pt>
                </c:numCache>
              </c:numRef>
            </c:plus>
            <c:minus>
              <c:numRef>
                <c:f>'Sheet 1 - county estimates'!$B$58:$J$58</c:f>
                <c:numCache>
                  <c:formatCode>General</c:formatCode>
                  <c:ptCount val="9"/>
                  <c:pt idx="0">
                    <c:v>2.0727779541100701E-2</c:v>
                  </c:pt>
                  <c:pt idx="1">
                    <c:v>2.0386245192550799E-2</c:v>
                  </c:pt>
                  <c:pt idx="2">
                    <c:v>0.13320546279843701</c:v>
                  </c:pt>
                  <c:pt idx="3">
                    <c:v>2.2551971558690601E-2</c:v>
                  </c:pt>
                  <c:pt idx="4">
                    <c:v>3.3680008492847198E-2</c:v>
                  </c:pt>
                  <c:pt idx="5">
                    <c:v>3.17515101838661E-2</c:v>
                  </c:pt>
                  <c:pt idx="6">
                    <c:v>6.8010404264371702E-2</c:v>
                  </c:pt>
                  <c:pt idx="7">
                    <c:v>2.1785332575781101E-2</c:v>
                  </c:pt>
                  <c:pt idx="8">
                    <c:v>2.57542168089953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8:$J$8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9:$J$9</c:f>
              <c:numCache>
                <c:formatCode>General</c:formatCode>
                <c:ptCount val="9"/>
                <c:pt idx="0">
                  <c:v>0.56075902540054001</c:v>
                </c:pt>
                <c:pt idx="1">
                  <c:v>0.43669073979488898</c:v>
                </c:pt>
                <c:pt idx="2">
                  <c:v>0.50892830252471399</c:v>
                </c:pt>
                <c:pt idx="3">
                  <c:v>0.29206923512940702</c:v>
                </c:pt>
                <c:pt idx="4">
                  <c:v>0.242329131279026</c:v>
                </c:pt>
                <c:pt idx="5">
                  <c:v>0.67350893811076196</c:v>
                </c:pt>
                <c:pt idx="6">
                  <c:v>0.43158529522383599</c:v>
                </c:pt>
                <c:pt idx="7">
                  <c:v>0.52120328106630098</c:v>
                </c:pt>
                <c:pt idx="8">
                  <c:v>0.828401558277906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69-B94F-87B3-F650CAE9A0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3816287277631694"/>
          <c:y val="0.2328455777990624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17</c:f>
              <c:strCache>
                <c:ptCount val="1"/>
                <c:pt idx="0">
                  <c:v>Sal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62:$J$62</c:f>
                <c:numCache>
                  <c:formatCode>General</c:formatCode>
                  <c:ptCount val="9"/>
                  <c:pt idx="0">
                    <c:v>1.4517490524081E-2</c:v>
                  </c:pt>
                  <c:pt idx="1">
                    <c:v>1.1860612683416399E-2</c:v>
                  </c:pt>
                  <c:pt idx="2">
                    <c:v>8.5770761030140197E-2</c:v>
                  </c:pt>
                  <c:pt idx="3">
                    <c:v>1.9167649878181502E-2</c:v>
                  </c:pt>
                  <c:pt idx="4">
                    <c:v>2.3997600265155201E-2</c:v>
                  </c:pt>
                  <c:pt idx="5">
                    <c:v>3.2814853130039297E-2</c:v>
                  </c:pt>
                  <c:pt idx="6">
                    <c:v>6.2488761052242901E-2</c:v>
                  </c:pt>
                  <c:pt idx="7">
                    <c:v>1.48317129763603E-2</c:v>
                  </c:pt>
                  <c:pt idx="8">
                    <c:v>1.7309623390170701E-2</c:v>
                  </c:pt>
                </c:numCache>
              </c:numRef>
            </c:plus>
            <c:minus>
              <c:numRef>
                <c:f>'Sheet 1 - county estimates'!$B$62:$J$62</c:f>
                <c:numCache>
                  <c:formatCode>General</c:formatCode>
                  <c:ptCount val="9"/>
                  <c:pt idx="0">
                    <c:v>1.4517490524081E-2</c:v>
                  </c:pt>
                  <c:pt idx="1">
                    <c:v>1.1860612683416399E-2</c:v>
                  </c:pt>
                  <c:pt idx="2">
                    <c:v>8.5770761030140197E-2</c:v>
                  </c:pt>
                  <c:pt idx="3">
                    <c:v>1.9167649878181502E-2</c:v>
                  </c:pt>
                  <c:pt idx="4">
                    <c:v>2.3997600265155201E-2</c:v>
                  </c:pt>
                  <c:pt idx="5">
                    <c:v>3.2814853130039297E-2</c:v>
                  </c:pt>
                  <c:pt idx="6">
                    <c:v>6.2488761052242901E-2</c:v>
                  </c:pt>
                  <c:pt idx="7">
                    <c:v>1.48317129763603E-2</c:v>
                  </c:pt>
                  <c:pt idx="8">
                    <c:v>1.73096233901707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16:$J$16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17:$J$17</c:f>
              <c:numCache>
                <c:formatCode>General</c:formatCode>
                <c:ptCount val="9"/>
                <c:pt idx="0">
                  <c:v>0.53469501700281796</c:v>
                </c:pt>
                <c:pt idx="1">
                  <c:v>0.482222985627423</c:v>
                </c:pt>
                <c:pt idx="2">
                  <c:v>0.59954162886046702</c:v>
                </c:pt>
                <c:pt idx="3">
                  <c:v>0.29778093183448701</c:v>
                </c:pt>
                <c:pt idx="4">
                  <c:v>0.210432229985373</c:v>
                </c:pt>
                <c:pt idx="5">
                  <c:v>0.64637662000104401</c:v>
                </c:pt>
                <c:pt idx="6">
                  <c:v>0.50812281824695205</c:v>
                </c:pt>
                <c:pt idx="7">
                  <c:v>0.59298234795392302</c:v>
                </c:pt>
                <c:pt idx="8">
                  <c:v>0.877428401397063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2E9-124E-8B1E-7B94800130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1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C9CAB-3498-B945-9DC9-F7E6A5DB0B94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88C8D-C0C2-6F48-9503-0FAE5FDE5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786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C9CAB-3498-B945-9DC9-F7E6A5DB0B94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88C8D-C0C2-6F48-9503-0FAE5FDE5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108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C9CAB-3498-B945-9DC9-F7E6A5DB0B94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88C8D-C0C2-6F48-9503-0FAE5FDE5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071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C9CAB-3498-B945-9DC9-F7E6A5DB0B94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88C8D-C0C2-6F48-9503-0FAE5FDE5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236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C9CAB-3498-B945-9DC9-F7E6A5DB0B94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88C8D-C0C2-6F48-9503-0FAE5FDE5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465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C9CAB-3498-B945-9DC9-F7E6A5DB0B94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88C8D-C0C2-6F48-9503-0FAE5FDE5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580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C9CAB-3498-B945-9DC9-F7E6A5DB0B94}" type="datetimeFigureOut">
              <a:rPr lang="en-US" smtClean="0"/>
              <a:t>4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88C8D-C0C2-6F48-9503-0FAE5FDE5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746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C9CAB-3498-B945-9DC9-F7E6A5DB0B94}" type="datetimeFigureOut">
              <a:rPr lang="en-US" smtClean="0"/>
              <a:t>4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88C8D-C0C2-6F48-9503-0FAE5FDE5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286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C9CAB-3498-B945-9DC9-F7E6A5DB0B94}" type="datetimeFigureOut">
              <a:rPr lang="en-US" smtClean="0"/>
              <a:t>4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88C8D-C0C2-6F48-9503-0FAE5FDE5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441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C9CAB-3498-B945-9DC9-F7E6A5DB0B94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88C8D-C0C2-6F48-9503-0FAE5FDE5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668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C9CAB-3498-B945-9DC9-F7E6A5DB0B94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88C8D-C0C2-6F48-9503-0FAE5FDE5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232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DC9CAB-3498-B945-9DC9-F7E6A5DB0B94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B88C8D-C0C2-6F48-9503-0FAE5FDE5F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72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Rectangle 24">
            <a:extLst>
              <a:ext uri="{FF2B5EF4-FFF2-40B4-BE49-F238E27FC236}">
                <a16:creationId xmlns:a16="http://schemas.microsoft.com/office/drawing/2014/main" id="{3791F7FF-D519-7847-82A9-0A2523F7FE22}"/>
              </a:ext>
            </a:extLst>
          </p:cNvPr>
          <p:cNvSpPr/>
          <p:nvPr/>
        </p:nvSpPr>
        <p:spPr>
          <a:xfrm>
            <a:off x="843271" y="6411231"/>
            <a:ext cx="760319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tabLst>
                <a:tab pos="171446" algn="l"/>
              </a:tabLst>
            </a:pP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5 Fig. Probability of </a:t>
            </a:r>
            <a:r>
              <a:rPr lang="en-US" sz="1200" i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. </a:t>
            </a:r>
            <a:r>
              <a:rPr lang="en-US" sz="1200" i="1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osichella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biotype 1 occurrence (mean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± SE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 at locations in Barton (A), Ellis (B), Geary (C), Dickinson (D), Greeley (E), Ellsworth (F), Saline (G) and Finney (H) county Kansas in 2014, 2015 and 2016. </a:t>
            </a:r>
            <a:endParaRPr lang="en-US" sz="12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ACE26C5-A38D-2B4E-9DDD-9601B4DF0678}"/>
              </a:ext>
            </a:extLst>
          </p:cNvPr>
          <p:cNvGrpSpPr/>
          <p:nvPr/>
        </p:nvGrpSpPr>
        <p:grpSpPr>
          <a:xfrm>
            <a:off x="535500" y="-148860"/>
            <a:ext cx="7628063" cy="6555412"/>
            <a:chOff x="535500" y="-148860"/>
            <a:chExt cx="7628063" cy="6555412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0D2EB1BE-8BCD-FD42-A066-BE1FEB325B1F}"/>
                </a:ext>
              </a:extLst>
            </p:cNvPr>
            <p:cNvGrpSpPr/>
            <p:nvPr/>
          </p:nvGrpSpPr>
          <p:grpSpPr>
            <a:xfrm>
              <a:off x="993237" y="-148860"/>
              <a:ext cx="7170326" cy="6318579"/>
              <a:chOff x="993237" y="-148860"/>
              <a:chExt cx="7170326" cy="6318579"/>
            </a:xfrm>
          </p:grpSpPr>
          <p:graphicFrame>
            <p:nvGraphicFramePr>
              <p:cNvPr id="6" name="Chart 5">
                <a:extLst>
                  <a:ext uri="{FF2B5EF4-FFF2-40B4-BE49-F238E27FC236}">
                    <a16:creationId xmlns:a16="http://schemas.microsoft.com/office/drawing/2014/main" id="{97FF8BC8-6C10-44AF-BCB4-C2130F12A6F5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537951786"/>
                  </p:ext>
                </p:extLst>
              </p:nvPr>
            </p:nvGraphicFramePr>
            <p:xfrm>
              <a:off x="1008506" y="-134267"/>
              <a:ext cx="3591564" cy="158319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7" name="Chart 6">
                <a:extLst>
                  <a:ext uri="{FF2B5EF4-FFF2-40B4-BE49-F238E27FC236}">
                    <a16:creationId xmlns:a16="http://schemas.microsoft.com/office/drawing/2014/main" id="{0DD64D2D-3934-419F-81BF-5C8E456A07F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54708418"/>
                  </p:ext>
                </p:extLst>
              </p:nvPr>
            </p:nvGraphicFramePr>
            <p:xfrm>
              <a:off x="4557368" y="1421845"/>
              <a:ext cx="3591564" cy="158173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8" name="Chart 7">
                <a:extLst>
                  <a:ext uri="{FF2B5EF4-FFF2-40B4-BE49-F238E27FC236}">
                    <a16:creationId xmlns:a16="http://schemas.microsoft.com/office/drawing/2014/main" id="{65BCFF82-F347-42A1-867E-EDCA79DD7B6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07874059"/>
                  </p:ext>
                </p:extLst>
              </p:nvPr>
            </p:nvGraphicFramePr>
            <p:xfrm>
              <a:off x="4571999" y="-148860"/>
              <a:ext cx="3591564" cy="158319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9" name="Chart 8">
                <a:extLst>
                  <a:ext uri="{FF2B5EF4-FFF2-40B4-BE49-F238E27FC236}">
                    <a16:creationId xmlns:a16="http://schemas.microsoft.com/office/drawing/2014/main" id="{38FA75C5-296C-4B9D-B9FF-BB7130ADC12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18941614"/>
                  </p:ext>
                </p:extLst>
              </p:nvPr>
            </p:nvGraphicFramePr>
            <p:xfrm>
              <a:off x="993237" y="1436390"/>
              <a:ext cx="3591564" cy="158173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10" name="Chart 9">
                <a:extLst>
                  <a:ext uri="{FF2B5EF4-FFF2-40B4-BE49-F238E27FC236}">
                    <a16:creationId xmlns:a16="http://schemas.microsoft.com/office/drawing/2014/main" id="{81B36224-6BF3-49BE-AA97-C352A89C2D7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397117833"/>
                  </p:ext>
                </p:extLst>
              </p:nvPr>
            </p:nvGraphicFramePr>
            <p:xfrm>
              <a:off x="995065" y="3012065"/>
              <a:ext cx="3591564" cy="158319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11" name="Chart 10">
                <a:extLst>
                  <a:ext uri="{FF2B5EF4-FFF2-40B4-BE49-F238E27FC236}">
                    <a16:creationId xmlns:a16="http://schemas.microsoft.com/office/drawing/2014/main" id="{2D06C90C-B9DD-4551-A9C3-885B0DD6714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291577184"/>
                  </p:ext>
                </p:extLst>
              </p:nvPr>
            </p:nvGraphicFramePr>
            <p:xfrm>
              <a:off x="4547127" y="4573438"/>
              <a:ext cx="3591564" cy="158173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graphicFrame>
            <p:nvGraphicFramePr>
              <p:cNvPr id="12" name="Chart 11">
                <a:extLst>
                  <a:ext uri="{FF2B5EF4-FFF2-40B4-BE49-F238E27FC236}">
                    <a16:creationId xmlns:a16="http://schemas.microsoft.com/office/drawing/2014/main" id="{64303B1A-B4E5-47BF-AEDA-D74E031C8AB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57093433"/>
                  </p:ext>
                </p:extLst>
              </p:nvPr>
            </p:nvGraphicFramePr>
            <p:xfrm>
              <a:off x="4571999" y="3002734"/>
              <a:ext cx="3591564" cy="158319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graphicFrame>
            <p:nvGraphicFramePr>
              <p:cNvPr id="13" name="Chart 12">
                <a:extLst>
                  <a:ext uri="{FF2B5EF4-FFF2-40B4-BE49-F238E27FC236}">
                    <a16:creationId xmlns:a16="http://schemas.microsoft.com/office/drawing/2014/main" id="{2C46D51E-9752-4D74-9910-5364FFB1EC6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14951937"/>
                  </p:ext>
                </p:extLst>
              </p:nvPr>
            </p:nvGraphicFramePr>
            <p:xfrm>
              <a:off x="993237" y="4587984"/>
              <a:ext cx="3591564" cy="158173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</p:grpSp>
        <p:sp>
          <p:nvSpPr>
            <p:cNvPr id="23" name="Text Box 18">
              <a:extLst>
                <a:ext uri="{FF2B5EF4-FFF2-40B4-BE49-F238E27FC236}">
                  <a16:creationId xmlns:a16="http://schemas.microsoft.com/office/drawing/2014/main" id="{715F24F1-52BA-8E4D-A308-725B5F091146}"/>
                </a:ext>
              </a:extLst>
            </p:cNvPr>
            <p:cNvSpPr txBox="1"/>
            <p:nvPr/>
          </p:nvSpPr>
          <p:spPr>
            <a:xfrm rot="10800000">
              <a:off x="535500" y="815584"/>
              <a:ext cx="397669" cy="469582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eaVert" wrap="square" lIns="68580" tIns="34290" rIns="68580" bIns="3429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Probability of </a:t>
              </a:r>
              <a:r>
                <a:rPr lang="en-US" sz="1400" b="1" i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A. </a:t>
              </a:r>
              <a:r>
                <a:rPr lang="en-US" sz="1400" b="1" i="1" dirty="0" err="1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toschiella</a:t>
              </a:r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 biotype 1 occurrence (mean </a:t>
              </a:r>
              <a:r>
                <a:rPr lang="en-US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± </a:t>
              </a:r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SE)</a:t>
              </a:r>
              <a:endPara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 Box 16">
              <a:extLst>
                <a:ext uri="{FF2B5EF4-FFF2-40B4-BE49-F238E27FC236}">
                  <a16:creationId xmlns:a16="http://schemas.microsoft.com/office/drawing/2014/main" id="{B82435C7-77A5-A84F-A2B2-20689143A350}"/>
                </a:ext>
              </a:extLst>
            </p:cNvPr>
            <p:cNvSpPr txBox="1"/>
            <p:nvPr/>
          </p:nvSpPr>
          <p:spPr>
            <a:xfrm>
              <a:off x="3610967" y="6139376"/>
              <a:ext cx="2067801" cy="267176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68580" tIns="34290" rIns="68580" bIns="3429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Sample Month and Year</a:t>
              </a:r>
              <a:endPara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CE27C20D-E789-C144-98A1-BD44C6952A6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339736" y="116129"/>
              <a:ext cx="300044" cy="260907"/>
            </a:xfrm>
            <a:prstGeom prst="rect">
              <a:avLst/>
            </a:prstGeom>
            <a:solidFill>
              <a:schemeClr val="bg1"/>
            </a:solidFill>
            <a:ln w="2667"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A</a:t>
              </a:r>
              <a:endParaRPr lang="en-US" sz="16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EB5B192A-FC7D-8B4E-ABE7-66ECC0781C1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941076" y="57937"/>
              <a:ext cx="273583" cy="244391"/>
            </a:xfrm>
            <a:prstGeom prst="rect">
              <a:avLst/>
            </a:prstGeom>
            <a:solidFill>
              <a:schemeClr val="bg1"/>
            </a:solidFill>
            <a:ln w="1270"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B</a:t>
              </a:r>
              <a:endParaRPr lang="en-US" sz="16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D3B4CA03-C246-A34E-9173-11EE39042B1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431632" y="1679649"/>
              <a:ext cx="189548" cy="171450"/>
            </a:xfrm>
            <a:prstGeom prst="rect">
              <a:avLst/>
            </a:prstGeom>
            <a:solidFill>
              <a:schemeClr val="bg1"/>
            </a:solidFill>
            <a:ln w="3175"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C</a:t>
              </a:r>
              <a:endParaRPr lang="en-US" sz="16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0F636952-7767-8444-93CF-57D80F85ADD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962214" y="1641127"/>
              <a:ext cx="189548" cy="171450"/>
            </a:xfrm>
            <a:prstGeom prst="rect">
              <a:avLst/>
            </a:prstGeom>
            <a:solidFill>
              <a:schemeClr val="bg1"/>
            </a:solidFill>
            <a:ln w="3175"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D</a:t>
              </a:r>
              <a:endParaRPr lang="en-US" sz="16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21">
              <a:extLst>
                <a:ext uri="{FF2B5EF4-FFF2-40B4-BE49-F238E27FC236}">
                  <a16:creationId xmlns:a16="http://schemas.microsoft.com/office/drawing/2014/main" id="{1504420D-1583-1D4A-8E02-B3F59C294B9B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1431632" y="3274338"/>
              <a:ext cx="185738" cy="171450"/>
            </a:xfrm>
            <a:prstGeom prst="rect">
              <a:avLst/>
            </a:prstGeom>
            <a:solidFill>
              <a:srgbClr val="FFFFFF"/>
            </a:solidFill>
            <a:ln w="3175">
              <a:noFill/>
              <a:miter lim="800000"/>
              <a:headEnd/>
              <a:tailEnd/>
            </a:ln>
          </p:spPr>
          <p:txBody>
            <a:bodyPr vert="horz" wrap="non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algn="ctr" defTabSz="685784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E</a:t>
              </a:r>
              <a:endParaRPr lang="en-US" altLang="en-US" sz="1200" dirty="0">
                <a:latin typeface="Arial" panose="020B0604020202020204" pitchFamily="34" charset="0"/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FF057F96-92D3-1C46-A803-3936ED81E66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986427" y="3257550"/>
              <a:ext cx="182880" cy="171450"/>
            </a:xfrm>
            <a:prstGeom prst="rect">
              <a:avLst/>
            </a:prstGeom>
            <a:solidFill>
              <a:schemeClr val="bg1"/>
            </a:solidFill>
            <a:ln w="3175">
              <a:noFill/>
            </a:ln>
          </p:spPr>
          <p:txBody>
            <a:bodyPr wrap="none">
              <a:noAutofit/>
            </a:bodyPr>
            <a:lstStyle/>
            <a:p>
              <a:pPr algn="ctr"/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F</a:t>
              </a:r>
              <a:endPara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21">
              <a:extLst>
                <a:ext uri="{FF2B5EF4-FFF2-40B4-BE49-F238E27FC236}">
                  <a16:creationId xmlns:a16="http://schemas.microsoft.com/office/drawing/2014/main" id="{4A00B469-8FC1-8448-9994-955DD959B85C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1414420" y="4859765"/>
              <a:ext cx="198835" cy="171450"/>
            </a:xfrm>
            <a:prstGeom prst="rect">
              <a:avLst/>
            </a:prstGeom>
            <a:solidFill>
              <a:srgbClr val="FFFFFF"/>
            </a:solidFill>
            <a:ln w="1270">
              <a:noFill/>
              <a:miter lim="800000"/>
              <a:headEnd/>
              <a:tailEnd/>
            </a:ln>
          </p:spPr>
          <p:txBody>
            <a:bodyPr vert="horz" wrap="non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algn="ctr" defTabSz="685784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G</a:t>
              </a:r>
              <a:endParaRPr lang="en-US" altLang="en-US" sz="1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6" name="Rectangle 11">
              <a:extLst>
                <a:ext uri="{FF2B5EF4-FFF2-40B4-BE49-F238E27FC236}">
                  <a16:creationId xmlns:a16="http://schemas.microsoft.com/office/drawing/2014/main" id="{434792DD-864D-E04D-BCEF-5F33389B6501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4945658" y="4837303"/>
              <a:ext cx="197644" cy="171450"/>
            </a:xfrm>
            <a:prstGeom prst="rect">
              <a:avLst/>
            </a:prstGeom>
            <a:solidFill>
              <a:srgbClr val="FFFFFF"/>
            </a:solidFill>
            <a:ln w="1270">
              <a:noFill/>
              <a:miter lim="800000"/>
              <a:headEnd/>
              <a:tailEnd/>
            </a:ln>
          </p:spPr>
          <p:txBody>
            <a:bodyPr vert="horz" wrap="non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algn="ctr" defTabSz="685784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PMingLiU" panose="02020500000000000000" pitchFamily="18" charset="-120"/>
                  <a:cs typeface="Calibri" panose="020F0502020204030204" pitchFamily="34" charset="0"/>
                </a:rPr>
                <a:t>H</a:t>
              </a:r>
              <a:endParaRPr lang="en-US" altLang="en-US" sz="1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8" name="Rectangle 15">
              <a:extLst>
                <a:ext uri="{FF2B5EF4-FFF2-40B4-BE49-F238E27FC236}">
                  <a16:creationId xmlns:a16="http://schemas.microsoft.com/office/drawing/2014/main" id="{3B174123-D30F-754E-8DDD-678E1DC92C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7284" y="4839277"/>
              <a:ext cx="138564" cy="2539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68580" tIns="34290" rIns="68580" bIns="3429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US" sz="1200" b="1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9" name="Rectangle 20">
              <a:extLst>
                <a:ext uri="{FF2B5EF4-FFF2-40B4-BE49-F238E27FC236}">
                  <a16:creationId xmlns:a16="http://schemas.microsoft.com/office/drawing/2014/main" id="{62111BAD-5A2F-D549-A41C-DCED14A240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7284" y="4999186"/>
              <a:ext cx="138564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68580" tIns="34290" rIns="68580" bIns="3429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US" sz="1350"/>
            </a:p>
          </p:txBody>
        </p:sp>
      </p:grpSp>
    </p:spTree>
    <p:extLst>
      <p:ext uri="{BB962C8B-B14F-4D97-AF65-F5344CB8AC3E}">
        <p14:creationId xmlns:p14="http://schemas.microsoft.com/office/powerpoint/2010/main" val="2092164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1</TotalTime>
  <Words>94</Words>
  <Application>Microsoft Macintosh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 Smith</dc:creator>
  <cp:lastModifiedBy>Microsoft Office User</cp:lastModifiedBy>
  <cp:revision>13</cp:revision>
  <dcterms:created xsi:type="dcterms:W3CDTF">2019-10-14T20:04:35Z</dcterms:created>
  <dcterms:modified xsi:type="dcterms:W3CDTF">2020-04-10T15:47:49Z</dcterms:modified>
</cp:coreProperties>
</file>